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267" r:id="rId2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pos="3672" userDrawn="1">
          <p15:clr>
            <a:srgbClr val="A4A3A4"/>
          </p15:clr>
        </p15:guide>
        <p15:guide id="4" pos="648" userDrawn="1">
          <p15:clr>
            <a:srgbClr val="A4A3A4"/>
          </p15:clr>
        </p15:guide>
        <p15:guide id="5" orient="horz" pos="367" userDrawn="1">
          <p15:clr>
            <a:srgbClr val="A4A3A4"/>
          </p15:clr>
        </p15:guide>
        <p15:guide id="6" orient="horz" pos="37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9F9F9F"/>
    <a:srgbClr val="C6C5C4"/>
    <a:srgbClr val="8D8C8A"/>
    <a:srgbClr val="525252"/>
    <a:srgbClr val="33CCCC"/>
    <a:srgbClr val="FF0000"/>
    <a:srgbClr val="C00000"/>
    <a:srgbClr val="408697"/>
    <a:srgbClr val="68000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B3237A3-C8ED-4FDD-9653-DFB1A4E1C85B}" v="2" dt="2025-06-23T21:29:12.30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51" autoAdjust="0"/>
    <p:restoredTop sz="93447" autoAdjust="0"/>
  </p:normalViewPr>
  <p:slideViewPr>
    <p:cSldViewPr snapToGrid="0">
      <p:cViewPr varScale="1">
        <p:scale>
          <a:sx n="81" d="100"/>
          <a:sy n="81" d="100"/>
        </p:scale>
        <p:origin x="3048" y="90"/>
      </p:cViewPr>
      <p:guideLst>
        <p:guide pos="3672"/>
        <p:guide pos="648"/>
        <p:guide orient="horz" pos="367"/>
        <p:guide orient="horz" pos="3792"/>
      </p:guideLst>
    </p:cSldViewPr>
  </p:slideViewPr>
  <p:outlineViewPr>
    <p:cViewPr>
      <p:scale>
        <a:sx n="33" d="100"/>
        <a:sy n="33" d="100"/>
      </p:scale>
      <p:origin x="0" y="-7419"/>
    </p:cViewPr>
  </p:outlineViewPr>
  <p:notesTextViewPr>
    <p:cViewPr>
      <p:scale>
        <a:sx n="400" d="100"/>
        <a:sy n="400" d="100"/>
      </p:scale>
      <p:origin x="0" y="0"/>
    </p:cViewPr>
  </p:notesTextViewPr>
  <p:sorterViewPr>
    <p:cViewPr>
      <p:scale>
        <a:sx n="74" d="100"/>
        <a:sy n="74" d="100"/>
      </p:scale>
      <p:origin x="0" y="0"/>
    </p:cViewPr>
  </p:sorterViewPr>
  <p:gridSpacing cx="182880" cy="18288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eike Schell" userId="+hwTHCJ9DPY+RcXtlOoxeiHCh/r8M9NERwcOBswqpyo=" providerId="None" clId="Web-{D0E174A4-FF77-410E-A064-A65E48C01CE0}"/>
    <pc:docChg chg="addSld modSld">
      <pc:chgData name="Mareike Schell" userId="+hwTHCJ9DPY+RcXtlOoxeiHCh/r8M9NERwcOBswqpyo=" providerId="None" clId="Web-{D0E174A4-FF77-410E-A064-A65E48C01CE0}" dt="2025-06-18T20:38:09.875" v="6"/>
      <pc:docMkLst>
        <pc:docMk/>
      </pc:docMkLst>
      <pc:sldChg chg="delSp">
        <pc:chgData name="Mareike Schell" userId="+hwTHCJ9DPY+RcXtlOoxeiHCh/r8M9NERwcOBswqpyo=" providerId="None" clId="Web-{D0E174A4-FF77-410E-A064-A65E48C01CE0}" dt="2025-06-18T20:38:07.875" v="5"/>
        <pc:sldMkLst>
          <pc:docMk/>
          <pc:sldMk cId="1691594351" sldId="2270"/>
        </pc:sldMkLst>
        <pc:spChg chg="del">
          <ac:chgData name="Mareike Schell" userId="+hwTHCJ9DPY+RcXtlOoxeiHCh/r8M9NERwcOBswqpyo=" providerId="None" clId="Web-{D0E174A4-FF77-410E-A064-A65E48C01CE0}" dt="2025-06-18T20:38:07.875" v="5"/>
          <ac:spMkLst>
            <pc:docMk/>
            <pc:sldMk cId="1691594351" sldId="2270"/>
            <ac:spMk id="4" creationId="{1EB32637-4065-5203-92A6-816C76BE9F93}"/>
          </ac:spMkLst>
        </pc:spChg>
        <pc:spChg chg="del">
          <ac:chgData name="Mareike Schell" userId="+hwTHCJ9DPY+RcXtlOoxeiHCh/r8M9NERwcOBswqpyo=" providerId="None" clId="Web-{D0E174A4-FF77-410E-A064-A65E48C01CE0}" dt="2025-06-18T20:38:07.875" v="4"/>
          <ac:spMkLst>
            <pc:docMk/>
            <pc:sldMk cId="1691594351" sldId="2270"/>
            <ac:spMk id="6" creationId="{2F9575D5-9BCF-EE54-D239-C7BA39B5210C}"/>
          </ac:spMkLst>
        </pc:spChg>
        <pc:spChg chg="del">
          <ac:chgData name="Mareike Schell" userId="+hwTHCJ9DPY+RcXtlOoxeiHCh/r8M9NERwcOBswqpyo=" providerId="None" clId="Web-{D0E174A4-FF77-410E-A064-A65E48C01CE0}" dt="2025-06-18T20:38:07.875" v="3"/>
          <ac:spMkLst>
            <pc:docMk/>
            <pc:sldMk cId="1691594351" sldId="2270"/>
            <ac:spMk id="7" creationId="{7713419C-40F1-166F-7685-12DD873E3889}"/>
          </ac:spMkLst>
        </pc:spChg>
        <pc:spChg chg="del">
          <ac:chgData name="Mareike Schell" userId="+hwTHCJ9DPY+RcXtlOoxeiHCh/r8M9NERwcOBswqpyo=" providerId="None" clId="Web-{D0E174A4-FF77-410E-A064-A65E48C01CE0}" dt="2025-06-18T20:38:07.875" v="2"/>
          <ac:spMkLst>
            <pc:docMk/>
            <pc:sldMk cId="1691594351" sldId="2270"/>
            <ac:spMk id="8" creationId="{5D6FC1C1-F155-861D-A7A1-E2651E6E9C66}"/>
          </ac:spMkLst>
        </pc:spChg>
        <pc:grpChg chg="del">
          <ac:chgData name="Mareike Schell" userId="+hwTHCJ9DPY+RcXtlOoxeiHCh/r8M9NERwcOBswqpyo=" providerId="None" clId="Web-{D0E174A4-FF77-410E-A064-A65E48C01CE0}" dt="2025-06-18T20:38:07.859" v="1"/>
          <ac:grpSpMkLst>
            <pc:docMk/>
            <pc:sldMk cId="1691594351" sldId="2270"/>
            <ac:grpSpMk id="9" creationId="{CC359C9F-7BC9-47CF-BEFC-0DA61A45203F}"/>
          </ac:grpSpMkLst>
        </pc:grpChg>
      </pc:sldChg>
      <pc:sldChg chg="addSp new">
        <pc:chgData name="Mareike Schell" userId="+hwTHCJ9DPY+RcXtlOoxeiHCh/r8M9NERwcOBswqpyo=" providerId="None" clId="Web-{D0E174A4-FF77-410E-A064-A65E48C01CE0}" dt="2025-06-18T20:38:09.875" v="6"/>
        <pc:sldMkLst>
          <pc:docMk/>
          <pc:sldMk cId="2105458467" sldId="2283"/>
        </pc:sldMkLst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4" creationId="{7713419C-40F1-166F-7685-12DD873E3889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9" creationId="{E33C9E2D-3BA5-16D6-C965-E9A2AD306141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10" creationId="{9BC17AB2-4076-8BD3-A3E3-58C3B64B6488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11" creationId="{8C21F97A-DCFA-6FE3-FC8F-60F295899015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14" creationId="{B7B2A7CA-C92B-A038-8147-A0958F7DCF6B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0" creationId="{618AA4CC-3E26-D8A3-AC7A-15E7738EF09B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1" creationId="{78CEB8C7-CC3D-BB06-5B57-E3A826AC8C92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3" creationId="{A42A442F-B98B-706D-6B50-F9D813670D0B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4" creationId="{E16C5DE1-F2ED-1EB1-FF6C-08C5706DA404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8" creationId="{EE79737A-C9DC-B00F-B02E-DD9960F96B8E}"/>
          </ac:spMkLst>
        </pc:spChg>
      </pc:sldChg>
    </pc:docChg>
  </pc:docChgLst>
  <pc:docChgLst>
    <pc:chgData name="Mareike Schell" userId="+hwTHCJ9DPY+RcXtlOoxeiHCh/r8M9NERwcOBswqpyo=" providerId="None" clId="Web-{DB3237A3-C8ED-4FDD-9653-DFB1A4E1C85B}"/>
    <pc:docChg chg="modSld">
      <pc:chgData name="Mareike Schell" userId="+hwTHCJ9DPY+RcXtlOoxeiHCh/r8M9NERwcOBswqpyo=" providerId="None" clId="Web-{DB3237A3-C8ED-4FDD-9653-DFB1A4E1C85B}" dt="2025-06-23T21:29:12.304" v="1" actId="1076"/>
      <pc:docMkLst>
        <pc:docMk/>
      </pc:docMkLst>
      <pc:sldChg chg="modSp">
        <pc:chgData name="Mareike Schell" userId="+hwTHCJ9DPY+RcXtlOoxeiHCh/r8M9NERwcOBswqpyo=" providerId="None" clId="Web-{DB3237A3-C8ED-4FDD-9653-DFB1A4E1C85B}" dt="2025-06-23T21:29:12.304" v="1" actId="1076"/>
        <pc:sldMkLst>
          <pc:docMk/>
          <pc:sldMk cId="957714345" sldId="2282"/>
        </pc:sldMkLst>
        <pc:spChg chg="mod">
          <ac:chgData name="Mareike Schell" userId="+hwTHCJ9DPY+RcXtlOoxeiHCh/r8M9NERwcOBswqpyo=" providerId="None" clId="Web-{DB3237A3-C8ED-4FDD-9653-DFB1A4E1C85B}" dt="2025-06-23T21:29:12.304" v="1" actId="1076"/>
          <ac:spMkLst>
            <pc:docMk/>
            <pc:sldMk cId="957714345" sldId="2282"/>
            <ac:spMk id="406" creationId="{944DE7CF-CC9C-B0F5-5AB0-2468A2E26644}"/>
          </ac:spMkLst>
        </pc:spChg>
      </pc:sldChg>
    </pc:docChg>
  </pc:docChgLst>
  <pc:docChgLst>
    <pc:chgData name="Mareike Schell" userId="+hwTHCJ9DPY+RcXtlOoxeiHCh/r8M9NERwcOBswqpyo=" providerId="None" clId="Web-{92842568-ACA6-4FF0-B290-0595DDCEF770}"/>
    <pc:docChg chg="modSld">
      <pc:chgData name="Mareike Schell" userId="+hwTHCJ9DPY+RcXtlOoxeiHCh/r8M9NERwcOBswqpyo=" providerId="None" clId="Web-{92842568-ACA6-4FF0-B290-0595DDCEF770}" dt="2025-05-02T22:19:57.215" v="187"/>
      <pc:docMkLst>
        <pc:docMk/>
      </pc:docMkLst>
      <pc:sldChg chg="addSp delSp modSp">
        <pc:chgData name="Mareike Schell" userId="+hwTHCJ9DPY+RcXtlOoxeiHCh/r8M9NERwcOBswqpyo=" providerId="None" clId="Web-{92842568-ACA6-4FF0-B290-0595DDCEF770}" dt="2025-05-02T22:17:23.756" v="140"/>
        <pc:sldMkLst>
          <pc:docMk/>
          <pc:sldMk cId="4273005573" sldId="2276"/>
        </pc:sldMkLst>
        <pc:spChg chg="del mod">
          <ac:chgData name="Mareike Schell" userId="+hwTHCJ9DPY+RcXtlOoxeiHCh/r8M9NERwcOBswqpyo=" providerId="None" clId="Web-{92842568-ACA6-4FF0-B290-0595DDCEF770}" dt="2025-05-02T22:17:23.756" v="138"/>
          <ac:spMkLst>
            <pc:docMk/>
            <pc:sldMk cId="4273005573" sldId="2276"/>
            <ac:spMk id="4" creationId="{7476FED3-6C14-9CA0-7EF0-ADF11E285B26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7"/>
          <ac:spMkLst>
            <pc:docMk/>
            <pc:sldMk cId="4273005573" sldId="2276"/>
            <ac:spMk id="5" creationId="{E3C59D4F-2741-7324-DA74-C21FD86C6C13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6"/>
          <ac:spMkLst>
            <pc:docMk/>
            <pc:sldMk cId="4273005573" sldId="2276"/>
            <ac:spMk id="6" creationId="{CACE87EA-B2AA-CAF5-88EA-9769811A81B9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5"/>
          <ac:spMkLst>
            <pc:docMk/>
            <pc:sldMk cId="4273005573" sldId="2276"/>
            <ac:spMk id="8" creationId="{2D886CBF-BFAA-2E47-805D-35FCA336A757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40"/>
          <ac:spMkLst>
            <pc:docMk/>
            <pc:sldMk cId="4273005573" sldId="2276"/>
            <ac:spMk id="123" creationId="{1C139171-2D45-B7BD-65B7-87213805B36A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9"/>
          <ac:spMkLst>
            <pc:docMk/>
            <pc:sldMk cId="4273005573" sldId="2276"/>
            <ac:spMk id="124" creationId="{74010334-5A8C-8AB3-3B8C-71654DF3E834}"/>
          </ac:spMkLst>
        </pc:spChg>
        <pc:cxnChg chg="add del mod">
          <ac:chgData name="Mareike Schell" userId="+hwTHCJ9DPY+RcXtlOoxeiHCh/r8M9NERwcOBswqpyo=" providerId="None" clId="Web-{92842568-ACA6-4FF0-B290-0595DDCEF770}" dt="2025-05-02T22:14:24.031" v="100"/>
          <ac:cxnSpMkLst>
            <pc:docMk/>
            <pc:sldMk cId="4273005573" sldId="2276"/>
            <ac:cxnSpMk id="2" creationId="{CECF07A4-3230-F0C6-0DE9-4B570FC92AA6}"/>
          </ac:cxnSpMkLst>
        </pc:cxnChg>
      </pc:sldChg>
      <pc:sldChg chg="addSp delSp modSp">
        <pc:chgData name="Mareike Schell" userId="+hwTHCJ9DPY+RcXtlOoxeiHCh/r8M9NERwcOBswqpyo=" providerId="None" clId="Web-{92842568-ACA6-4FF0-B290-0595DDCEF770}" dt="2025-05-02T22:19:57.215" v="187"/>
        <pc:sldMkLst>
          <pc:docMk/>
          <pc:sldMk cId="459051783" sldId="2280"/>
        </pc:sldMkLst>
        <pc:spChg chg="del">
          <ac:chgData name="Mareike Schell" userId="+hwTHCJ9DPY+RcXtlOoxeiHCh/r8M9NERwcOBswqpyo=" providerId="None" clId="Web-{92842568-ACA6-4FF0-B290-0595DDCEF770}" dt="2025-05-02T22:16:59.786" v="132"/>
          <ac:spMkLst>
            <pc:docMk/>
            <pc:sldMk cId="459051783" sldId="2280"/>
            <ac:spMk id="11" creationId="{A8EB7B5A-443C-867C-CA7A-A53CC47CDCB1}"/>
          </ac:spMkLst>
        </pc:spChg>
        <pc:spChg chg="add mod">
          <ac:chgData name="Mareike Schell" userId="+hwTHCJ9DPY+RcXtlOoxeiHCh/r8M9NERwcOBswqpyo=" providerId="None" clId="Web-{92842568-ACA6-4FF0-B290-0595DDCEF770}" dt="2025-05-02T22:18:03.132" v="158" actId="1076"/>
          <ac:spMkLst>
            <pc:docMk/>
            <pc:sldMk cId="459051783" sldId="2280"/>
            <ac:spMk id="12" creationId="{1C139171-2D45-B7BD-65B7-87213805B36A}"/>
          </ac:spMkLst>
        </pc:spChg>
        <pc:spChg chg="add mod">
          <ac:chgData name="Mareike Schell" userId="+hwTHCJ9DPY+RcXtlOoxeiHCh/r8M9NERwcOBswqpyo=" providerId="None" clId="Web-{92842568-ACA6-4FF0-B290-0595DDCEF770}" dt="2025-05-02T22:18:03.164" v="159" actId="1076"/>
          <ac:spMkLst>
            <pc:docMk/>
            <pc:sldMk cId="459051783" sldId="2280"/>
            <ac:spMk id="13" creationId="{74010334-5A8C-8AB3-3B8C-71654DF3E834}"/>
          </ac:spMkLst>
        </pc:spChg>
        <pc:spChg chg="add mod">
          <ac:chgData name="Mareike Schell" userId="+hwTHCJ9DPY+RcXtlOoxeiHCh/r8M9NERwcOBswqpyo=" providerId="None" clId="Web-{92842568-ACA6-4FF0-B290-0595DDCEF770}" dt="2025-05-02T22:19:29.245" v="179" actId="1076"/>
          <ac:spMkLst>
            <pc:docMk/>
            <pc:sldMk cId="459051783" sldId="2280"/>
            <ac:spMk id="14" creationId="{7476FED3-6C14-9CA0-7EF0-ADF11E285B26}"/>
          </ac:spMkLst>
        </pc:spChg>
        <pc:spChg chg="add mod">
          <ac:chgData name="Mareike Schell" userId="+hwTHCJ9DPY+RcXtlOoxeiHCh/r8M9NERwcOBswqpyo=" providerId="None" clId="Web-{92842568-ACA6-4FF0-B290-0595DDCEF770}" dt="2025-05-02T22:18:03.257" v="161" actId="1076"/>
          <ac:spMkLst>
            <pc:docMk/>
            <pc:sldMk cId="459051783" sldId="2280"/>
            <ac:spMk id="23" creationId="{E3C59D4F-2741-7324-DA74-C21FD86C6C13}"/>
          </ac:spMkLst>
        </pc:spChg>
        <pc:spChg chg="add mod">
          <ac:chgData name="Mareike Schell" userId="+hwTHCJ9DPY+RcXtlOoxeiHCh/r8M9NERwcOBswqpyo=" providerId="None" clId="Web-{92842568-ACA6-4FF0-B290-0595DDCEF770}" dt="2025-05-02T22:18:03.289" v="162" actId="1076"/>
          <ac:spMkLst>
            <pc:docMk/>
            <pc:sldMk cId="459051783" sldId="2280"/>
            <ac:spMk id="24" creationId="{CACE87EA-B2AA-CAF5-88EA-9769811A81B9}"/>
          </ac:spMkLst>
        </pc:spChg>
        <pc:spChg chg="add mod">
          <ac:chgData name="Mareike Schell" userId="+hwTHCJ9DPY+RcXtlOoxeiHCh/r8M9NERwcOBswqpyo=" providerId="None" clId="Web-{92842568-ACA6-4FF0-B290-0595DDCEF770}" dt="2025-05-02T22:18:03.320" v="163" actId="1076"/>
          <ac:spMkLst>
            <pc:docMk/>
            <pc:sldMk cId="459051783" sldId="2280"/>
            <ac:spMk id="25" creationId="{2D886CBF-BFAA-2E47-805D-35FCA336A757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28" creationId="{DD7E0284-6262-AE94-F830-FBF0417BEC52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30" creationId="{209BF54C-DFEA-0F7F-5D44-9D598493C30D}"/>
          </ac:spMkLst>
        </pc:spChg>
        <pc:spChg chg="mod">
          <ac:chgData name="Mareike Schell" userId="+hwTHCJ9DPY+RcXtlOoxeiHCh/r8M9NERwcOBswqpyo=" providerId="None" clId="Web-{92842568-ACA6-4FF0-B290-0595DDCEF770}" dt="2025-05-02T22:19:44.136" v="185" actId="1076"/>
          <ac:spMkLst>
            <pc:docMk/>
            <pc:sldMk cId="459051783" sldId="2280"/>
            <ac:spMk id="34" creationId="{27DEC4EB-8210-F330-8699-9B4A582A7DA1}"/>
          </ac:spMkLst>
        </pc:spChg>
        <pc:spChg chg="mod">
          <ac:chgData name="Mareike Schell" userId="+hwTHCJ9DPY+RcXtlOoxeiHCh/r8M9NERwcOBswqpyo=" providerId="None" clId="Web-{92842568-ACA6-4FF0-B290-0595DDCEF770}" dt="2025-05-02T22:19:29.182" v="177" actId="1076"/>
          <ac:spMkLst>
            <pc:docMk/>
            <pc:sldMk cId="459051783" sldId="2280"/>
            <ac:spMk id="65" creationId="{3353F172-8E2D-D17D-3089-70122D299134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66" creationId="{4692D747-95A7-FDA9-F3FB-00E230374148}"/>
          </ac:spMkLst>
        </pc:spChg>
        <pc:spChg chg="mod">
          <ac:chgData name="Mareike Schell" userId="+hwTHCJ9DPY+RcXtlOoxeiHCh/r8M9NERwcOBswqpyo=" providerId="None" clId="Web-{92842568-ACA6-4FF0-B290-0595DDCEF770}" dt="2025-05-02T22:19:34.057" v="181" actId="1076"/>
          <ac:spMkLst>
            <pc:docMk/>
            <pc:sldMk cId="459051783" sldId="2280"/>
            <ac:spMk id="69" creationId="{B6CC28BD-61EC-758A-CEE0-4810A441FA91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84" creationId="{0306307D-B979-D43B-CD11-5AE5124C31E6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88" creationId="{1E9BE69A-D0CF-B0AC-A1AC-375B5A6B1F22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00" creationId="{2A182F72-85E1-A235-B8EA-C99C7A24AFA4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07" creationId="{B2F1C922-B519-0F24-A40B-A78B65B80F09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12" creationId="{B422BFCF-499A-1EA2-D6B4-9409148052D0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16" creationId="{E208B5B3-F7AB-8B7C-948B-C25340F795D0}"/>
          </ac:spMkLst>
        </pc:spChg>
        <pc:spChg chg="mod">
          <ac:chgData name="Mareike Schell" userId="+hwTHCJ9DPY+RcXtlOoxeiHCh/r8M9NERwcOBswqpyo=" providerId="None" clId="Web-{92842568-ACA6-4FF0-B290-0595DDCEF770}" dt="2025-05-02T22:19:29.214" v="178" actId="1076"/>
          <ac:spMkLst>
            <pc:docMk/>
            <pc:sldMk cId="459051783" sldId="2280"/>
            <ac:spMk id="119" creationId="{4ED3FE10-5FD8-8676-BA03-9EBEF5283149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20" creationId="{8922343C-9A58-2616-5BF6-687FBC2BF168}"/>
          </ac:spMkLst>
        </pc:spChg>
        <pc:grpChg chg="add del">
          <ac:chgData name="Mareike Schell" userId="+hwTHCJ9DPY+RcXtlOoxeiHCh/r8M9NERwcOBswqpyo=" providerId="None" clId="Web-{92842568-ACA6-4FF0-B290-0595DDCEF770}" dt="2025-05-02T22:17:28.194" v="141"/>
          <ac:grpSpMkLst>
            <pc:docMk/>
            <pc:sldMk cId="459051783" sldId="2280"/>
            <ac:grpSpMk id="2" creationId="{908CE240-C904-3ADB-540F-6998173295B9}"/>
          </ac:grpSpMkLst>
        </pc:grpChg>
        <pc:graphicFrameChg chg="mod">
          <ac:chgData name="Mareike Schell" userId="+hwTHCJ9DPY+RcXtlOoxeiHCh/r8M9NERwcOBswqpyo=" providerId="None" clId="Web-{92842568-ACA6-4FF0-B290-0595DDCEF770}" dt="2025-05-02T22:19:44.105" v="184" actId="1076"/>
          <ac:graphicFrameMkLst>
            <pc:docMk/>
            <pc:sldMk cId="459051783" sldId="2280"/>
            <ac:graphicFrameMk id="32" creationId="{8323550C-CAA8-CD19-AAB1-16F8DE4BA7D2}"/>
          </ac:graphicFrameMkLst>
        </pc:graphicFrameChg>
        <pc:graphicFrameChg chg="mod">
          <ac:chgData name="Mareike Schell" userId="+hwTHCJ9DPY+RcXtlOoxeiHCh/r8M9NERwcOBswqpyo=" providerId="None" clId="Web-{92842568-ACA6-4FF0-B290-0595DDCEF770}" dt="2025-05-02T22:19:29.151" v="176" actId="1076"/>
          <ac:graphicFrameMkLst>
            <pc:docMk/>
            <pc:sldMk cId="459051783" sldId="2280"/>
            <ac:graphicFrameMk id="63" creationId="{64D06C85-6552-E708-267A-5E8DC415877E}"/>
          </ac:graphicFrameMkLst>
        </pc:graphicFrameChg>
        <pc:graphicFrameChg chg="mod">
          <ac:chgData name="Mareike Schell" userId="+hwTHCJ9DPY+RcXtlOoxeiHCh/r8M9NERwcOBswqpyo=" providerId="None" clId="Web-{92842568-ACA6-4FF0-B290-0595DDCEF770}" dt="2025-05-02T22:19:34.011" v="180" actId="1076"/>
          <ac:graphicFrameMkLst>
            <pc:docMk/>
            <pc:sldMk cId="459051783" sldId="2280"/>
            <ac:graphicFrameMk id="68" creationId="{9868219A-2DDE-D7AE-E945-D36EAEFADBB6}"/>
          </ac:graphicFrameMkLst>
        </pc:graphicFrameChg>
        <pc:cxnChg chg="add del mod">
          <ac:chgData name="Mareike Schell" userId="+hwTHCJ9DPY+RcXtlOoxeiHCh/r8M9NERwcOBswqpyo=" providerId="None" clId="Web-{92842568-ACA6-4FF0-B290-0595DDCEF770}" dt="2025-05-02T22:19:57.215" v="187"/>
          <ac:cxnSpMkLst>
            <pc:docMk/>
            <pc:sldMk cId="459051783" sldId="2280"/>
            <ac:cxnSpMk id="26" creationId="{F1B4FF4F-98B5-EA33-1243-2009F14444E9}"/>
          </ac:cxnSpMkLst>
        </pc:cxnChg>
      </pc:sldChg>
    </pc:docChg>
  </pc:docChgLst>
  <pc:docChgLst>
    <pc:chgData name="Mareike Schell" userId="+hwTHCJ9DPY+RcXtlOoxeiHCh/r8M9NERwcOBswqpyo=" providerId="None" clId="Web-{105243D0-230D-4A85-9D06-0BF99DA71ECB}"/>
    <pc:docChg chg="modSld sldOrd">
      <pc:chgData name="Mareike Schell" userId="+hwTHCJ9DPY+RcXtlOoxeiHCh/r8M9NERwcOBswqpyo=" providerId="None" clId="Web-{105243D0-230D-4A85-9D06-0BF99DA71ECB}" dt="2025-06-20T20:45:51.369" v="3" actId="20577"/>
      <pc:docMkLst>
        <pc:docMk/>
      </pc:docMkLst>
      <pc:sldChg chg="modSp">
        <pc:chgData name="Mareike Schell" userId="+hwTHCJ9DPY+RcXtlOoxeiHCh/r8M9NERwcOBswqpyo=" providerId="None" clId="Web-{105243D0-230D-4A85-9D06-0BF99DA71ECB}" dt="2025-06-20T20:45:51.369" v="3" actId="20577"/>
        <pc:sldMkLst>
          <pc:docMk/>
          <pc:sldMk cId="604687140" sldId="2262"/>
        </pc:sldMkLst>
        <pc:spChg chg="mod">
          <ac:chgData name="Mareike Schell" userId="+hwTHCJ9DPY+RcXtlOoxeiHCh/r8M9NERwcOBswqpyo=" providerId="None" clId="Web-{105243D0-230D-4A85-9D06-0BF99DA71ECB}" dt="2025-06-20T20:45:51.369" v="3" actId="20577"/>
          <ac:spMkLst>
            <pc:docMk/>
            <pc:sldMk cId="604687140" sldId="2262"/>
            <ac:spMk id="211" creationId="{174E3E88-3800-7243-D6A2-12C1978CFDD7}"/>
          </ac:spMkLst>
        </pc:spChg>
      </pc:sldChg>
      <pc:sldChg chg="modSp ord">
        <pc:chgData name="Mareike Schell" userId="+hwTHCJ9DPY+RcXtlOoxeiHCh/r8M9NERwcOBswqpyo=" providerId="None" clId="Web-{105243D0-230D-4A85-9D06-0BF99DA71ECB}" dt="2025-06-20T20:45:47.165" v="2" actId="20577"/>
        <pc:sldMkLst>
          <pc:docMk/>
          <pc:sldMk cId="2105458467" sldId="2283"/>
        </pc:sldMkLst>
        <pc:spChg chg="mod">
          <ac:chgData name="Mareike Schell" userId="+hwTHCJ9DPY+RcXtlOoxeiHCh/r8M9NERwcOBswqpyo=" providerId="None" clId="Web-{105243D0-230D-4A85-9D06-0BF99DA71ECB}" dt="2025-06-20T20:45:47.165" v="2" actId="20577"/>
          <ac:spMkLst>
            <pc:docMk/>
            <pc:sldMk cId="2105458467" sldId="2283"/>
            <ac:spMk id="7" creationId="{7730057E-B75C-B8F1-09E6-EF14151BAC4A}"/>
          </ac:spMkLst>
        </pc:spChg>
      </pc:sldChg>
    </pc:docChg>
  </pc:docChgLst>
  <pc:docChgLst>
    <pc:chgData name="Mareike Schell" userId="+hwTHCJ9DPY+RcXtlOoxeiHCh/r8M9NERwcOBswqpyo=" providerId="None" clId="Web-{9ADCC2D3-70B3-4043-AB62-6F6C91297EF6}"/>
    <pc:docChg chg="modSld">
      <pc:chgData name="Mareike Schell" userId="+hwTHCJ9DPY+RcXtlOoxeiHCh/r8M9NERwcOBswqpyo=" providerId="None" clId="Web-{9ADCC2D3-70B3-4043-AB62-6F6C91297EF6}" dt="2025-05-02T23:23:05.316" v="6" actId="20577"/>
      <pc:docMkLst>
        <pc:docMk/>
      </pc:docMkLst>
      <pc:sldChg chg="modSp">
        <pc:chgData name="Mareike Schell" userId="+hwTHCJ9DPY+RcXtlOoxeiHCh/r8M9NERwcOBswqpyo=" providerId="None" clId="Web-{9ADCC2D3-70B3-4043-AB62-6F6C91297EF6}" dt="2025-05-02T23:22:52.659" v="4" actId="20577"/>
        <pc:sldMkLst>
          <pc:docMk/>
          <pc:sldMk cId="3419203025" sldId="2260"/>
        </pc:sldMkLst>
        <pc:spChg chg="mod">
          <ac:chgData name="Mareike Schell" userId="+hwTHCJ9DPY+RcXtlOoxeiHCh/r8M9NERwcOBswqpyo=" providerId="None" clId="Web-{9ADCC2D3-70B3-4043-AB62-6F6C91297EF6}" dt="2025-05-02T23:22:52.659" v="4" actId="20577"/>
          <ac:spMkLst>
            <pc:docMk/>
            <pc:sldMk cId="3419203025" sldId="2260"/>
            <ac:spMk id="252" creationId="{1BF8FC5C-5A86-EF66-E60A-C0E4B0A1E09E}"/>
          </ac:spMkLst>
        </pc:spChg>
      </pc:sldChg>
      <pc:sldChg chg="modSp">
        <pc:chgData name="Mareike Schell" userId="+hwTHCJ9DPY+RcXtlOoxeiHCh/r8M9NERwcOBswqpyo=" providerId="None" clId="Web-{9ADCC2D3-70B3-4043-AB62-6F6C91297EF6}" dt="2025-05-02T23:23:05.316" v="6" actId="20577"/>
        <pc:sldMkLst>
          <pc:docMk/>
          <pc:sldMk cId="604687140" sldId="2262"/>
        </pc:sldMkLst>
        <pc:spChg chg="mod">
          <ac:chgData name="Mareike Schell" userId="+hwTHCJ9DPY+RcXtlOoxeiHCh/r8M9NERwcOBswqpyo=" providerId="None" clId="Web-{9ADCC2D3-70B3-4043-AB62-6F6C91297EF6}" dt="2025-05-02T23:23:05.316" v="6" actId="20577"/>
          <ac:spMkLst>
            <pc:docMk/>
            <pc:sldMk cId="604687140" sldId="2262"/>
            <ac:spMk id="271" creationId="{39C151FB-3E65-7BA5-BD19-E8588ED1F7B0}"/>
          </ac:spMkLst>
        </pc:spChg>
      </pc:sldChg>
    </pc:docChg>
  </pc:docChgLst>
  <pc:docChgLst>
    <pc:chgData name="Mareike Schell" userId="+hwTHCJ9DPY+RcXtlOoxeiHCh/r8M9NERwcOBswqpyo=" providerId="None" clId="Web-{6C2CC828-A83C-4AAC-92D0-9AF3D4BC5B7A}"/>
    <pc:docChg chg="delSld">
      <pc:chgData name="Mareike Schell" userId="+hwTHCJ9DPY+RcXtlOoxeiHCh/r8M9NERwcOBswqpyo=" providerId="None" clId="Web-{6C2CC828-A83C-4AAC-92D0-9AF3D4BC5B7A}" dt="2025-05-03T23:31:10.031" v="4"/>
      <pc:docMkLst>
        <pc:docMk/>
      </pc:docMkLst>
      <pc:sldChg chg="del">
        <pc:chgData name="Mareike Schell" userId="+hwTHCJ9DPY+RcXtlOoxeiHCh/r8M9NERwcOBswqpyo=" providerId="None" clId="Web-{6C2CC828-A83C-4AAC-92D0-9AF3D4BC5B7A}" dt="2025-05-03T23:31:10.031" v="4"/>
        <pc:sldMkLst>
          <pc:docMk/>
          <pc:sldMk cId="1311454994" sldId="2269"/>
        </pc:sldMkLst>
      </pc:sldChg>
      <pc:sldChg chg="del">
        <pc:chgData name="Mareike Schell" userId="+hwTHCJ9DPY+RcXtlOoxeiHCh/r8M9NERwcOBswqpyo=" providerId="None" clId="Web-{6C2CC828-A83C-4AAC-92D0-9AF3D4BC5B7A}" dt="2025-05-03T23:31:01.764" v="0"/>
        <pc:sldMkLst>
          <pc:docMk/>
          <pc:sldMk cId="2534225001" sldId="2276"/>
        </pc:sldMkLst>
      </pc:sldChg>
      <pc:sldChg chg="del">
        <pc:chgData name="Mareike Schell" userId="+hwTHCJ9DPY+RcXtlOoxeiHCh/r8M9NERwcOBswqpyo=" providerId="None" clId="Web-{6C2CC828-A83C-4AAC-92D0-9AF3D4BC5B7A}" dt="2025-05-03T23:31:06.343" v="2"/>
        <pc:sldMkLst>
          <pc:docMk/>
          <pc:sldMk cId="121866281" sldId="2278"/>
        </pc:sldMkLst>
      </pc:sldChg>
      <pc:sldChg chg="del">
        <pc:chgData name="Mareike Schell" userId="+hwTHCJ9DPY+RcXtlOoxeiHCh/r8M9NERwcOBswqpyo=" providerId="None" clId="Web-{6C2CC828-A83C-4AAC-92D0-9AF3D4BC5B7A}" dt="2025-05-03T23:31:04.296" v="1"/>
        <pc:sldMkLst>
          <pc:docMk/>
          <pc:sldMk cId="263700232" sldId="2279"/>
        </pc:sldMkLst>
      </pc:sldChg>
      <pc:sldChg chg="del">
        <pc:chgData name="Mareike Schell" userId="+hwTHCJ9DPY+RcXtlOoxeiHCh/r8M9NERwcOBswqpyo=" providerId="None" clId="Web-{6C2CC828-A83C-4AAC-92D0-9AF3D4BC5B7A}" dt="2025-05-03T23:31:08.421" v="3"/>
        <pc:sldMkLst>
          <pc:docMk/>
          <pc:sldMk cId="1470452761" sldId="2282"/>
        </pc:sldMkLst>
      </pc:sldChg>
    </pc:docChg>
  </pc:docChgLst>
  <pc:docChgLst>
    <pc:chgData name="Mareike Schell" userId="+hwTHCJ9DPY+RcXtlOoxeiHCh/r8M9NERwcOBswqpyo=" providerId="None" clId="Web-{6B771CB8-5B8A-46C4-BD43-ECA176944BA4}"/>
    <pc:docChg chg="modSld">
      <pc:chgData name="Mareike Schell" userId="+hwTHCJ9DPY+RcXtlOoxeiHCh/r8M9NERwcOBswqpyo=" providerId="None" clId="Web-{6B771CB8-5B8A-46C4-BD43-ECA176944BA4}" dt="2025-06-05T15:12:30.297" v="7" actId="1076"/>
      <pc:docMkLst>
        <pc:docMk/>
      </pc:docMkLst>
      <pc:sldChg chg="addSp modSp">
        <pc:chgData name="Mareike Schell" userId="+hwTHCJ9DPY+RcXtlOoxeiHCh/r8M9NERwcOBswqpyo=" providerId="None" clId="Web-{6B771CB8-5B8A-46C4-BD43-ECA176944BA4}" dt="2025-06-05T15:12:30.297" v="7" actId="1076"/>
        <pc:sldMkLst>
          <pc:docMk/>
          <pc:sldMk cId="1691594351" sldId="2270"/>
        </pc:sldMkLst>
        <pc:spChg chg="add mod">
          <ac:chgData name="Mareike Schell" userId="+hwTHCJ9DPY+RcXtlOoxeiHCh/r8M9NERwcOBswqpyo=" providerId="None" clId="Web-{6B771CB8-5B8A-46C4-BD43-ECA176944BA4}" dt="2025-06-05T15:12:30.297" v="7" actId="1076"/>
          <ac:spMkLst>
            <pc:docMk/>
            <pc:sldMk cId="1691594351" sldId="2270"/>
            <ac:spMk id="22" creationId="{42A24069-71DE-949D-E209-59B51AC2C383}"/>
          </ac:spMkLst>
        </pc:spChg>
        <pc:spChg chg="mod">
          <ac:chgData name="Mareike Schell" userId="+hwTHCJ9DPY+RcXtlOoxeiHCh/r8M9NERwcOBswqpyo=" providerId="None" clId="Web-{6B771CB8-5B8A-46C4-BD43-ECA176944BA4}" dt="2025-06-05T15:12:12.969" v="3" actId="20577"/>
          <ac:spMkLst>
            <pc:docMk/>
            <pc:sldMk cId="1691594351" sldId="2270"/>
            <ac:spMk id="34" creationId="{833BF64A-985B-6CFD-BA2F-30B59E3BBD1A}"/>
          </ac:spMkLst>
        </pc:spChg>
      </pc:sldChg>
    </pc:docChg>
  </pc:docChgLst>
  <pc:docChgLst>
    <pc:chgData name="Mareike Schell" userId="+hwTHCJ9DPY+RcXtlOoxeiHCh/r8M9NERwcOBswqpyo=" providerId="None" clId="Web-{2165B5CB-A405-40F9-9B6D-C976A6FD1273}"/>
    <pc:docChg chg="modSld">
      <pc:chgData name="Mareike Schell" userId="+hwTHCJ9DPY+RcXtlOoxeiHCh/r8M9NERwcOBswqpyo=" providerId="None" clId="Web-{2165B5CB-A405-40F9-9B6D-C976A6FD1273}" dt="2025-06-18T20:41:44.502" v="68"/>
      <pc:docMkLst>
        <pc:docMk/>
      </pc:docMkLst>
      <pc:sldChg chg="addSp delSp modSp">
        <pc:chgData name="Mareike Schell" userId="+hwTHCJ9DPY+RcXtlOoxeiHCh/r8M9NERwcOBswqpyo=" providerId="None" clId="Web-{2165B5CB-A405-40F9-9B6D-C976A6FD1273}" dt="2025-06-18T20:41:44.502" v="68"/>
        <pc:sldMkLst>
          <pc:docMk/>
          <pc:sldMk cId="2105458467" sldId="2283"/>
        </pc:sldMkLst>
        <pc:spChg chg="mod">
          <ac:chgData name="Mareike Schell" userId="+hwTHCJ9DPY+RcXtlOoxeiHCh/r8M9NERwcOBswqpyo=" providerId="None" clId="Web-{2165B5CB-A405-40F9-9B6D-C976A6FD1273}" dt="2025-06-18T20:41:29.095" v="59" actId="1076"/>
          <ac:spMkLst>
            <pc:docMk/>
            <pc:sldMk cId="2105458467" sldId="2283"/>
            <ac:spMk id="20" creationId="{618AA4CC-3E26-D8A3-AC7A-15E7738EF09B}"/>
          </ac:spMkLst>
        </pc:spChg>
        <pc:spChg chg="del mod">
          <ac:chgData name="Mareike Schell" userId="+hwTHCJ9DPY+RcXtlOoxeiHCh/r8M9NERwcOBswqpyo=" providerId="None" clId="Web-{2165B5CB-A405-40F9-9B6D-C976A6FD1273}" dt="2025-06-18T20:40:35.718" v="21"/>
          <ac:spMkLst>
            <pc:docMk/>
            <pc:sldMk cId="2105458467" sldId="2283"/>
            <ac:spMk id="21" creationId="{78CEB8C7-CC3D-BB06-5B57-E3A826AC8C92}"/>
          </ac:spMkLst>
        </pc:spChg>
        <pc:spChg chg="mod">
          <ac:chgData name="Mareike Schell" userId="+hwTHCJ9DPY+RcXtlOoxeiHCh/r8M9NERwcOBswqpyo=" providerId="None" clId="Web-{2165B5CB-A405-40F9-9B6D-C976A6FD1273}" dt="2025-06-18T20:41:29.173" v="60" actId="1076"/>
          <ac:spMkLst>
            <pc:docMk/>
            <pc:sldMk cId="2105458467" sldId="2283"/>
            <ac:spMk id="22" creationId="{A1A6C24D-FECE-59DA-B996-8DFE9DE853F2}"/>
          </ac:spMkLst>
        </pc:spChg>
        <pc:spChg chg="mod">
          <ac:chgData name="Mareike Schell" userId="+hwTHCJ9DPY+RcXtlOoxeiHCh/r8M9NERwcOBswqpyo=" providerId="None" clId="Web-{2165B5CB-A405-40F9-9B6D-C976A6FD1273}" dt="2025-06-18T20:41:29.251" v="61" actId="1076"/>
          <ac:spMkLst>
            <pc:docMk/>
            <pc:sldMk cId="2105458467" sldId="2283"/>
            <ac:spMk id="23" creationId="{A42A442F-B98B-706D-6B50-F9D813670D0B}"/>
          </ac:spMkLst>
        </pc:spChg>
        <pc:spChg chg="mod">
          <ac:chgData name="Mareike Schell" userId="+hwTHCJ9DPY+RcXtlOoxeiHCh/r8M9NERwcOBswqpyo=" providerId="None" clId="Web-{2165B5CB-A405-40F9-9B6D-C976A6FD1273}" dt="2025-06-18T20:41:29.407" v="62" actId="1076"/>
          <ac:spMkLst>
            <pc:docMk/>
            <pc:sldMk cId="2105458467" sldId="2283"/>
            <ac:spMk id="24" creationId="{E16C5DE1-F2ED-1EB1-FF6C-08C5706DA404}"/>
          </ac:spMkLst>
        </pc:spChg>
        <pc:grpChg chg="mod">
          <ac:chgData name="Mareike Schell" userId="+hwTHCJ9DPY+RcXtlOoxeiHCh/r8M9NERwcOBswqpyo=" providerId="None" clId="Web-{2165B5CB-A405-40F9-9B6D-C976A6FD1273}" dt="2025-06-18T20:39:03.309" v="0" actId="1076"/>
          <ac:grpSpMkLst>
            <pc:docMk/>
            <pc:sldMk cId="2105458467" sldId="2283"/>
            <ac:grpSpMk id="6" creationId="{CC359C9F-7BC9-47CF-BEFC-0DA61A45203F}"/>
          </ac:grpSpMkLst>
        </pc:grpChg>
        <pc:picChg chg="mod">
          <ac:chgData name="Mareike Schell" userId="+hwTHCJ9DPY+RcXtlOoxeiHCh/r8M9NERwcOBswqpyo=" providerId="None" clId="Web-{2165B5CB-A405-40F9-9B6D-C976A6FD1273}" dt="2025-06-18T20:41:36.767" v="65" actId="1076"/>
          <ac:picMkLst>
            <pc:docMk/>
            <pc:sldMk cId="2105458467" sldId="2283"/>
            <ac:picMk id="18" creationId="{6E240840-1449-DA4C-6AC0-EB1FC169058B}"/>
          </ac:picMkLst>
        </pc:picChg>
        <pc:picChg chg="mod">
          <ac:chgData name="Mareike Schell" userId="+hwTHCJ9DPY+RcXtlOoxeiHCh/r8M9NERwcOBswqpyo=" providerId="None" clId="Web-{2165B5CB-A405-40F9-9B6D-C976A6FD1273}" dt="2025-06-18T20:39:30.638" v="8" actId="1076"/>
          <ac:picMkLst>
            <pc:docMk/>
            <pc:sldMk cId="2105458467" sldId="2283"/>
            <ac:picMk id="25" creationId="{893FF338-FEF2-3D63-8B17-F48584EFABB2}"/>
          </ac:picMkLst>
        </pc:picChg>
        <pc:picChg chg="mod">
          <ac:chgData name="Mareike Schell" userId="+hwTHCJ9DPY+RcXtlOoxeiHCh/r8M9NERwcOBswqpyo=" providerId="None" clId="Web-{2165B5CB-A405-40F9-9B6D-C976A6FD1273}" dt="2025-06-18T20:41:41.642" v="67" actId="1076"/>
          <ac:picMkLst>
            <pc:docMk/>
            <pc:sldMk cId="2105458467" sldId="2283"/>
            <ac:picMk id="26" creationId="{EFB16A03-E386-547F-FCE8-9303B0799495}"/>
          </ac:picMkLst>
        </pc:picChg>
        <pc:picChg chg="mod">
          <ac:chgData name="Mareike Schell" userId="+hwTHCJ9DPY+RcXtlOoxeiHCh/r8M9NERwcOBswqpyo=" providerId="None" clId="Web-{2165B5CB-A405-40F9-9B6D-C976A6FD1273}" dt="2025-06-18T20:41:36.861" v="66" actId="1076"/>
          <ac:picMkLst>
            <pc:docMk/>
            <pc:sldMk cId="2105458467" sldId="2283"/>
            <ac:picMk id="27" creationId="{076030E0-19B1-1657-571D-19A6133B904D}"/>
          </ac:picMkLst>
        </pc:picChg>
        <pc:cxnChg chg="add del mod">
          <ac:chgData name="Mareike Schell" userId="+hwTHCJ9DPY+RcXtlOoxeiHCh/r8M9NERwcOBswqpyo=" providerId="None" clId="Web-{2165B5CB-A405-40F9-9B6D-C976A6FD1273}" dt="2025-06-18T20:41:44.502" v="68"/>
          <ac:cxnSpMkLst>
            <pc:docMk/>
            <pc:sldMk cId="2105458467" sldId="2283"/>
            <ac:cxnSpMk id="30" creationId="{A775A2B3-A78C-99EB-06CE-E35072B4883E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66" tIns="46584" rIns="93166" bIns="4658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66" tIns="46584" rIns="93166" bIns="46584" rtlCol="0"/>
          <a:lstStyle>
            <a:lvl1pPr algn="r">
              <a:defRPr sz="1200"/>
            </a:lvl1pPr>
          </a:lstStyle>
          <a:p>
            <a:fld id="{B8E76031-5083-42A3-AEB2-84104042EB62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84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6" tIns="46584" rIns="93166" bIns="4658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9"/>
          </a:xfrm>
          <a:prstGeom prst="rect">
            <a:avLst/>
          </a:prstGeom>
        </p:spPr>
        <p:txBody>
          <a:bodyPr vert="horz" lIns="93166" tIns="46584" rIns="93166" bIns="4658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3037840" cy="466433"/>
          </a:xfrm>
          <a:prstGeom prst="rect">
            <a:avLst/>
          </a:prstGeom>
        </p:spPr>
        <p:txBody>
          <a:bodyPr vert="horz" lIns="93166" tIns="46584" rIns="93166" bIns="4658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9"/>
            <a:ext cx="3037840" cy="466433"/>
          </a:xfrm>
          <a:prstGeom prst="rect">
            <a:avLst/>
          </a:prstGeom>
        </p:spPr>
        <p:txBody>
          <a:bodyPr vert="horz" lIns="93166" tIns="46584" rIns="93166" bIns="46584" rtlCol="0" anchor="b"/>
          <a:lstStyle>
            <a:lvl1pPr algn="r">
              <a:defRPr sz="1200"/>
            </a:lvl1pPr>
          </a:lstStyle>
          <a:p>
            <a:fld id="{716B66B5-9926-446B-9214-7B7D28BAF4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234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6B66B5-9926-446B-9214-7B7D28BAF47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2566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819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475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508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51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56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259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807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24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36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246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587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A8459-7E93-4F1B-BD53-910F08855FC0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61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png"/><Relationship Id="rId4" Type="http://schemas.openxmlformats.org/officeDocument/2006/relationships/image" Target="../media/image1.emf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023398AA-8547-2C20-5795-65514F0D84BF}"/>
              </a:ext>
            </a:extLst>
          </p:cNvPr>
          <p:cNvGrpSpPr/>
          <p:nvPr/>
        </p:nvGrpSpPr>
        <p:grpSpPr>
          <a:xfrm>
            <a:off x="501122" y="496161"/>
            <a:ext cx="3606367" cy="1670485"/>
            <a:chOff x="852810" y="496161"/>
            <a:chExt cx="3606367" cy="1670485"/>
          </a:xfrm>
        </p:grpSpPr>
        <p:grpSp>
          <p:nvGrpSpPr>
            <p:cNvPr id="70" name="Group 69"/>
            <p:cNvGrpSpPr/>
            <p:nvPr/>
          </p:nvGrpSpPr>
          <p:grpSpPr>
            <a:xfrm>
              <a:off x="3097906" y="721146"/>
              <a:ext cx="1361271" cy="1445500"/>
              <a:chOff x="2194596" y="860425"/>
              <a:chExt cx="1361271" cy="1445500"/>
            </a:xfrm>
          </p:grpSpPr>
          <p:grpSp>
            <p:nvGrpSpPr>
              <p:cNvPr id="72" name="Group 71">
                <a:extLst>
                  <a:ext uri="{FF2B5EF4-FFF2-40B4-BE49-F238E27FC236}">
                    <a16:creationId xmlns:a16="http://schemas.microsoft.com/office/drawing/2014/main" id="{C33B90F5-D631-7206-97CE-0121B26B8FB8}"/>
                  </a:ext>
                </a:extLst>
              </p:cNvPr>
              <p:cNvGrpSpPr/>
              <p:nvPr/>
            </p:nvGrpSpPr>
            <p:grpSpPr>
              <a:xfrm>
                <a:off x="2194596" y="860425"/>
                <a:ext cx="1361271" cy="1445500"/>
                <a:chOff x="1164981" y="668035"/>
                <a:chExt cx="1361271" cy="1445500"/>
              </a:xfrm>
            </p:grpSpPr>
            <p:graphicFrame>
              <p:nvGraphicFramePr>
                <p:cNvPr id="94" name="Object 93">
                  <a:extLst>
                    <a:ext uri="{FF2B5EF4-FFF2-40B4-BE49-F238E27FC236}">
                      <a16:creationId xmlns:a16="http://schemas.microsoft.com/office/drawing/2014/main" id="{2EFA7EEE-B296-778E-21DF-0E58A18A2B2D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680345427"/>
                    </p:ext>
                  </p:extLst>
                </p:nvPr>
              </p:nvGraphicFramePr>
              <p:xfrm>
                <a:off x="1310360" y="668035"/>
                <a:ext cx="1082675" cy="118586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3" imgW="1082568" imgH="1185995" progId="Prism10.Document">
                        <p:embed/>
                      </p:oleObj>
                    </mc:Choice>
                    <mc:Fallback>
                      <p:oleObj name="Prism 10" r:id="rId3" imgW="1082568" imgH="1185995" progId="Prism10.Document">
                        <p:embed/>
                        <p:pic>
                          <p:nvPicPr>
                            <p:cNvPr id="94" name="Object 93">
                              <a:extLst>
                                <a:ext uri="{FF2B5EF4-FFF2-40B4-BE49-F238E27FC236}">
                                  <a16:creationId xmlns:a16="http://schemas.microsoft.com/office/drawing/2014/main" id="{2EFA7EEE-B296-778E-21DF-0E58A18A2B2D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10360" y="668035"/>
                              <a:ext cx="1082675" cy="118586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D17A701C-D8AF-D074-DB4D-C892D7938D96}"/>
                    </a:ext>
                  </a:extLst>
                </p:cNvPr>
                <p:cNvSpPr txBox="1"/>
                <p:nvPr/>
              </p:nvSpPr>
              <p:spPr>
                <a:xfrm>
                  <a:off x="1164981" y="1851925"/>
                  <a:ext cx="136127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log10(adj p-value)</a:t>
                  </a:r>
                </a:p>
              </p:txBody>
            </p:sp>
          </p:grp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D25A3F60-D3CE-60BC-0A8E-A90C03ACF5EF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395882" y="1927819"/>
                <a:ext cx="70532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C2D616A4-6657-33BE-9204-A5B49C95BA2C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839966" y="1927819"/>
                <a:ext cx="70532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61F2E2A0-2DA7-F607-7770-B795119CC73E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255180" y="1927819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8F1326BC-5372-8124-95D9-66895CBD4FA2}"/>
                </a:ext>
              </a:extLst>
            </p:cNvPr>
            <p:cNvGrpSpPr/>
            <p:nvPr/>
          </p:nvGrpSpPr>
          <p:grpSpPr>
            <a:xfrm>
              <a:off x="852810" y="496161"/>
              <a:ext cx="3346990" cy="1238748"/>
              <a:chOff x="-1080191" y="354011"/>
              <a:chExt cx="3346990" cy="1238748"/>
            </a:xfrm>
          </p:grpSpPr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B3B4121C-311F-808E-15FA-D9E19251C64A}"/>
                  </a:ext>
                </a:extLst>
              </p:cNvPr>
              <p:cNvSpPr txBox="1"/>
              <p:nvPr/>
            </p:nvSpPr>
            <p:spPr>
              <a:xfrm>
                <a:off x="-626942" y="354011"/>
                <a:ext cx="289374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ncreased in L-KO Pericentral Hepatocytes 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DF8D2577-4D4A-23BF-AD9C-1E84BCD48D27}"/>
                  </a:ext>
                </a:extLst>
              </p:cNvPr>
              <p:cNvSpPr txBox="1"/>
              <p:nvPr/>
            </p:nvSpPr>
            <p:spPr>
              <a:xfrm>
                <a:off x="-924699" y="628515"/>
                <a:ext cx="236795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gulation of Cholesterol Biosynthesis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77C2EB7C-C76E-1ED0-204E-BA9D72433787}"/>
                  </a:ext>
                </a:extLst>
              </p:cNvPr>
              <p:cNvSpPr txBox="1"/>
              <p:nvPr/>
            </p:nvSpPr>
            <p:spPr>
              <a:xfrm>
                <a:off x="-1080191" y="814072"/>
                <a:ext cx="25234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vation of Gene Expression by SREBF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CB91EB57-B5D7-E060-557C-B8DBD2E94520}"/>
                  </a:ext>
                </a:extLst>
              </p:cNvPr>
              <p:cNvSpPr txBox="1"/>
              <p:nvPr/>
            </p:nvSpPr>
            <p:spPr>
              <a:xfrm>
                <a:off x="-39841" y="988653"/>
                <a:ext cx="14830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etabolism of Steroids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44F6F436-C58D-FA7C-D7F6-CD56F981C3F4}"/>
                  </a:ext>
                </a:extLst>
              </p:cNvPr>
              <p:cNvSpPr txBox="1"/>
              <p:nvPr/>
            </p:nvSpPr>
            <p:spPr>
              <a:xfrm>
                <a:off x="94810" y="1173782"/>
                <a:ext cx="134844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etabolism of Lipids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4B9CA0A1-2E7F-0F7D-3274-E2F6A116235B}"/>
                  </a:ext>
                </a:extLst>
              </p:cNvPr>
              <p:cNvSpPr txBox="1"/>
              <p:nvPr/>
            </p:nvSpPr>
            <p:spPr>
              <a:xfrm>
                <a:off x="-139229" y="1346538"/>
                <a:ext cx="15824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holesterol Biosynthesis</a:t>
                </a:r>
              </a:p>
            </p:txBody>
          </p:sp>
        </p:grp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19CF75F2-DA53-CA64-8169-7A663418B7DE}"/>
              </a:ext>
            </a:extLst>
          </p:cNvPr>
          <p:cNvSpPr txBox="1">
            <a:spLocks/>
          </p:cNvSpPr>
          <p:nvPr/>
        </p:nvSpPr>
        <p:spPr>
          <a:xfrm>
            <a:off x="245473" y="411539"/>
            <a:ext cx="129844" cy="215444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BE0F688-F78E-042B-BF31-57F486D80FB1}"/>
              </a:ext>
            </a:extLst>
          </p:cNvPr>
          <p:cNvSpPr txBox="1">
            <a:spLocks/>
          </p:cNvSpPr>
          <p:nvPr/>
        </p:nvSpPr>
        <p:spPr>
          <a:xfrm>
            <a:off x="236076" y="6001201"/>
            <a:ext cx="129844" cy="215444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algn="l"/>
            <a:r>
              <a:rPr lang="en-US" sz="1400" b="1" dirty="0">
                <a:latin typeface="Arial"/>
                <a:cs typeface="Arial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059A9897-267E-517E-0D81-35EF4787ECC9}"/>
              </a:ext>
            </a:extLst>
          </p:cNvPr>
          <p:cNvGrpSpPr/>
          <p:nvPr/>
        </p:nvGrpSpPr>
        <p:grpSpPr>
          <a:xfrm>
            <a:off x="497168" y="2391887"/>
            <a:ext cx="3610321" cy="1633715"/>
            <a:chOff x="848856" y="2387556"/>
            <a:chExt cx="3610321" cy="1633715"/>
          </a:xfrm>
        </p:grpSpPr>
        <p:grpSp>
          <p:nvGrpSpPr>
            <p:cNvPr id="96" name="Group 95"/>
            <p:cNvGrpSpPr/>
            <p:nvPr/>
          </p:nvGrpSpPr>
          <p:grpSpPr>
            <a:xfrm>
              <a:off x="3097907" y="2616042"/>
              <a:ext cx="1361270" cy="1405229"/>
              <a:chOff x="5540516" y="860425"/>
              <a:chExt cx="1361270" cy="1405229"/>
            </a:xfrm>
          </p:grpSpPr>
          <p:grpSp>
            <p:nvGrpSpPr>
              <p:cNvPr id="97" name="Group 96">
                <a:extLst>
                  <a:ext uri="{FF2B5EF4-FFF2-40B4-BE49-F238E27FC236}">
                    <a16:creationId xmlns:a16="http://schemas.microsoft.com/office/drawing/2014/main" id="{C62BBAF9-0569-7B4F-C404-799EA0A386BC}"/>
                  </a:ext>
                </a:extLst>
              </p:cNvPr>
              <p:cNvGrpSpPr/>
              <p:nvPr/>
            </p:nvGrpSpPr>
            <p:grpSpPr>
              <a:xfrm>
                <a:off x="5540516" y="860425"/>
                <a:ext cx="1361270" cy="1405229"/>
                <a:chOff x="1169153" y="668035"/>
                <a:chExt cx="1361270" cy="1405229"/>
              </a:xfrm>
            </p:grpSpPr>
            <p:graphicFrame>
              <p:nvGraphicFramePr>
                <p:cNvPr id="101" name="Object 100">
                  <a:extLst>
                    <a:ext uri="{FF2B5EF4-FFF2-40B4-BE49-F238E27FC236}">
                      <a16:creationId xmlns:a16="http://schemas.microsoft.com/office/drawing/2014/main" id="{7EB495AF-931D-79C4-ACA1-AC3B317D76DB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336969692"/>
                    </p:ext>
                  </p:extLst>
                </p:nvPr>
              </p:nvGraphicFramePr>
              <p:xfrm>
                <a:off x="1310300" y="668035"/>
                <a:ext cx="1082675" cy="118586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5" imgW="1082568" imgH="1185995" progId="Prism10.Document">
                        <p:embed/>
                      </p:oleObj>
                    </mc:Choice>
                    <mc:Fallback>
                      <p:oleObj name="Prism 10" r:id="rId5" imgW="1082568" imgH="1185995" progId="Prism10.Document">
                        <p:embed/>
                        <p:pic>
                          <p:nvPicPr>
                            <p:cNvPr id="101" name="Object 100">
                              <a:extLst>
                                <a:ext uri="{FF2B5EF4-FFF2-40B4-BE49-F238E27FC236}">
                                  <a16:creationId xmlns:a16="http://schemas.microsoft.com/office/drawing/2014/main" id="{7EB495AF-931D-79C4-ACA1-AC3B317D76DB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10300" y="668035"/>
                              <a:ext cx="1082675" cy="118586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02" name="TextBox 101">
                  <a:extLst>
                    <a:ext uri="{FF2B5EF4-FFF2-40B4-BE49-F238E27FC236}">
                      <a16:creationId xmlns:a16="http://schemas.microsoft.com/office/drawing/2014/main" id="{A11C0261-446D-4DB9-6C9A-47986F7DA189}"/>
                    </a:ext>
                  </a:extLst>
                </p:cNvPr>
                <p:cNvSpPr txBox="1"/>
                <p:nvPr/>
              </p:nvSpPr>
              <p:spPr>
                <a:xfrm>
                  <a:off x="1169153" y="1811654"/>
                  <a:ext cx="136127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log10(adj p-value)</a:t>
                  </a:r>
                </a:p>
              </p:txBody>
            </p:sp>
          </p:grp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5E095CBE-9E05-0840-294E-FE4321298F04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5741801" y="192847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381FD7E3-23D6-8BD5-1074-4EBD056BFA2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6185885" y="1928475"/>
                <a:ext cx="70532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A27335FF-6940-309C-A8FC-643CBF042D30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6601099" y="1928475"/>
                <a:ext cx="141064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3C8EC6C5-7CF6-8875-769F-73F610C54661}"/>
                </a:ext>
              </a:extLst>
            </p:cNvPr>
            <p:cNvGrpSpPr/>
            <p:nvPr/>
          </p:nvGrpSpPr>
          <p:grpSpPr>
            <a:xfrm>
              <a:off x="848856" y="2387556"/>
              <a:ext cx="3311717" cy="1238748"/>
              <a:chOff x="-1080191" y="354011"/>
              <a:chExt cx="3311717" cy="1238748"/>
            </a:xfrm>
          </p:grpSpPr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DA9E1414-AC20-DC4C-2CAA-58D0466F6B03}"/>
                  </a:ext>
                </a:extLst>
              </p:cNvPr>
              <p:cNvSpPr txBox="1"/>
              <p:nvPr/>
            </p:nvSpPr>
            <p:spPr>
              <a:xfrm>
                <a:off x="-591683" y="354011"/>
                <a:ext cx="28232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ncreased in L-KO Periportal Hepatocytes 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881F5094-1552-FE20-803F-1A7DFBDCF093}"/>
                  </a:ext>
                </a:extLst>
              </p:cNvPr>
              <p:cNvSpPr txBox="1"/>
              <p:nvPr/>
            </p:nvSpPr>
            <p:spPr>
              <a:xfrm>
                <a:off x="-924699" y="628515"/>
                <a:ext cx="236795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egulation of Cholesterol Biosynthesis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6A6BE9C1-ADB9-A906-181B-91D2BCD396AB}"/>
                  </a:ext>
                </a:extLst>
              </p:cNvPr>
              <p:cNvSpPr txBox="1"/>
              <p:nvPr/>
            </p:nvSpPr>
            <p:spPr>
              <a:xfrm>
                <a:off x="-1080191" y="814072"/>
                <a:ext cx="25234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vation of Gene Expression by SREBF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C7C7C463-CFA5-400E-7549-66B538FB161A}"/>
                  </a:ext>
                </a:extLst>
              </p:cNvPr>
              <p:cNvSpPr txBox="1"/>
              <p:nvPr/>
            </p:nvSpPr>
            <p:spPr>
              <a:xfrm>
                <a:off x="-39841" y="988653"/>
                <a:ext cx="14830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etabolism of Steroids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C596FEAB-CA92-992D-73BF-45BD505D0886}"/>
                  </a:ext>
                </a:extLst>
              </p:cNvPr>
              <p:cNvSpPr txBox="1"/>
              <p:nvPr/>
            </p:nvSpPr>
            <p:spPr>
              <a:xfrm>
                <a:off x="-139227" y="1173782"/>
                <a:ext cx="15824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holesterol Biosynthesis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51113F71-F7D3-7D67-70F2-505C5540C1C6}"/>
                  </a:ext>
                </a:extLst>
              </p:cNvPr>
              <p:cNvSpPr txBox="1"/>
              <p:nvPr/>
            </p:nvSpPr>
            <p:spPr>
              <a:xfrm>
                <a:off x="-116785" y="1346538"/>
                <a:ext cx="1560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XR-mediated Signaling</a:t>
                </a:r>
              </a:p>
            </p:txBody>
          </p:sp>
        </p:grp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41099DBB-0C8B-1055-7A28-6EAFE2AF7C63}"/>
              </a:ext>
            </a:extLst>
          </p:cNvPr>
          <p:cNvGrpSpPr/>
          <p:nvPr/>
        </p:nvGrpSpPr>
        <p:grpSpPr>
          <a:xfrm>
            <a:off x="124688" y="4250843"/>
            <a:ext cx="3981911" cy="1677936"/>
            <a:chOff x="476376" y="4250843"/>
            <a:chExt cx="3981911" cy="1677936"/>
          </a:xfrm>
        </p:grpSpPr>
        <p:grpSp>
          <p:nvGrpSpPr>
            <p:cNvPr id="103" name="Group 102"/>
            <p:cNvGrpSpPr/>
            <p:nvPr/>
          </p:nvGrpSpPr>
          <p:grpSpPr>
            <a:xfrm>
              <a:off x="3097017" y="4478665"/>
              <a:ext cx="1361270" cy="1450114"/>
              <a:chOff x="2919294" y="2616200"/>
              <a:chExt cx="1361270" cy="1450114"/>
            </a:xfrm>
          </p:grpSpPr>
          <p:grpSp>
            <p:nvGrpSpPr>
              <p:cNvPr id="104" name="Group 103">
                <a:extLst>
                  <a:ext uri="{FF2B5EF4-FFF2-40B4-BE49-F238E27FC236}">
                    <a16:creationId xmlns:a16="http://schemas.microsoft.com/office/drawing/2014/main" id="{41F221AA-18C6-F58E-032E-423E1FD3EA1B}"/>
                  </a:ext>
                </a:extLst>
              </p:cNvPr>
              <p:cNvGrpSpPr/>
              <p:nvPr/>
            </p:nvGrpSpPr>
            <p:grpSpPr>
              <a:xfrm>
                <a:off x="2919294" y="2616200"/>
                <a:ext cx="1361270" cy="1450114"/>
                <a:chOff x="1166754" y="668651"/>
                <a:chExt cx="1361270" cy="1450114"/>
              </a:xfrm>
            </p:grpSpPr>
            <p:graphicFrame>
              <p:nvGraphicFramePr>
                <p:cNvPr id="108" name="Object 107">
                  <a:extLst>
                    <a:ext uri="{FF2B5EF4-FFF2-40B4-BE49-F238E27FC236}">
                      <a16:creationId xmlns:a16="http://schemas.microsoft.com/office/drawing/2014/main" id="{0014F667-6924-E3A2-41D1-42E3E872B481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207584323"/>
                    </p:ext>
                  </p:extLst>
                </p:nvPr>
              </p:nvGraphicFramePr>
              <p:xfrm>
                <a:off x="1309748" y="668651"/>
                <a:ext cx="1082675" cy="118586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7" imgW="1082568" imgH="1185995" progId="Prism10.Document">
                        <p:embed/>
                      </p:oleObj>
                    </mc:Choice>
                    <mc:Fallback>
                      <p:oleObj name="Prism 10" r:id="rId7" imgW="1082568" imgH="1185995" progId="Prism10.Document">
                        <p:embed/>
                        <p:pic>
                          <p:nvPicPr>
                            <p:cNvPr id="108" name="Object 107">
                              <a:extLst>
                                <a:ext uri="{FF2B5EF4-FFF2-40B4-BE49-F238E27FC236}">
                                  <a16:creationId xmlns:a16="http://schemas.microsoft.com/office/drawing/2014/main" id="{0014F667-6924-E3A2-41D1-42E3E872B48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09748" y="668651"/>
                              <a:ext cx="1082675" cy="118586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080B2A54-3DB3-AE74-48CF-EB029841A343}"/>
                    </a:ext>
                  </a:extLst>
                </p:cNvPr>
                <p:cNvSpPr txBox="1"/>
                <p:nvPr/>
              </p:nvSpPr>
              <p:spPr>
                <a:xfrm>
                  <a:off x="1166754" y="1857155"/>
                  <a:ext cx="136127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log10(adj p-value)</a:t>
                  </a:r>
                </a:p>
              </p:txBody>
            </p:sp>
          </p:grp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54277227-A4F2-B95F-DE4E-222A416C8C3D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123309" y="3685057"/>
                <a:ext cx="70532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17CBC479-A12E-9962-58F0-CE0726B6218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564663" y="3685057"/>
                <a:ext cx="70532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E558AAD8-8930-2B11-2F9D-86FE6710D8DF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015363" y="3685057"/>
                <a:ext cx="70532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8B1388EC-5797-B6B6-9818-755CE081CA44}"/>
                </a:ext>
              </a:extLst>
            </p:cNvPr>
            <p:cNvGrpSpPr/>
            <p:nvPr/>
          </p:nvGrpSpPr>
          <p:grpSpPr>
            <a:xfrm>
              <a:off x="476376" y="4250843"/>
              <a:ext cx="3529993" cy="1238748"/>
              <a:chOff x="-1453691" y="354011"/>
              <a:chExt cx="3529993" cy="1238748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47EF88B2-A5CE-D9A1-B701-0B07150C4D4A}"/>
                  </a:ext>
                </a:extLst>
              </p:cNvPr>
              <p:cNvSpPr txBox="1"/>
              <p:nvPr/>
            </p:nvSpPr>
            <p:spPr>
              <a:xfrm>
                <a:off x="-811027" y="354011"/>
                <a:ext cx="288732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Decreased in L-KO Periportal Hepatocytes 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820C0EBE-781C-D0DF-3DD6-2D4ABDD0E16A}"/>
                  </a:ext>
                </a:extLst>
              </p:cNvPr>
              <p:cNvSpPr txBox="1"/>
              <p:nvPr/>
            </p:nvSpPr>
            <p:spPr>
              <a:xfrm>
                <a:off x="-1453691" y="628515"/>
                <a:ext cx="2896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igand Binding/Uptake by Scavenger Receptors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B0FA0C5E-D9E8-B4B7-D4E0-75791C23D488}"/>
                  </a:ext>
                </a:extLst>
              </p:cNvPr>
              <p:cNvSpPr txBox="1"/>
              <p:nvPr/>
            </p:nvSpPr>
            <p:spPr>
              <a:xfrm>
                <a:off x="-272277" y="814072"/>
                <a:ext cx="17155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-Protein Mediated Events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5C69509F-09F8-2CAF-53F4-0F89C186D073}"/>
                  </a:ext>
                </a:extLst>
              </p:cNvPr>
              <p:cNvSpPr txBox="1"/>
              <p:nvPr/>
            </p:nvSpPr>
            <p:spPr>
              <a:xfrm>
                <a:off x="192594" y="988653"/>
                <a:ext cx="12506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eurotransmission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FA0EBBC8-D20A-66BF-FD61-ED8DE0BB22AC}"/>
                  </a:ext>
                </a:extLst>
              </p:cNvPr>
              <p:cNvSpPr txBox="1"/>
              <p:nvPr/>
            </p:nvSpPr>
            <p:spPr>
              <a:xfrm>
                <a:off x="-1136296" y="1173782"/>
                <a:ext cx="257955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AC1 Activation Downstream of NMDARs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FBA88401-F5A8-88F1-482C-1BC7DF6B7E8F}"/>
                  </a:ext>
                </a:extLst>
              </p:cNvPr>
              <p:cNvSpPr txBox="1"/>
              <p:nvPr/>
            </p:nvSpPr>
            <p:spPr>
              <a:xfrm>
                <a:off x="-195333" y="1346538"/>
                <a:ext cx="16385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NF43 Mutants Signaling</a:t>
                </a:r>
              </a:p>
            </p:txBody>
          </p:sp>
        </p:grp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A6818820-8386-69A7-14A0-6E975694705E}"/>
              </a:ext>
            </a:extLst>
          </p:cNvPr>
          <p:cNvGrpSpPr/>
          <p:nvPr/>
        </p:nvGrpSpPr>
        <p:grpSpPr>
          <a:xfrm>
            <a:off x="213578" y="6494730"/>
            <a:ext cx="4534243" cy="1183303"/>
            <a:chOff x="575318" y="6344005"/>
            <a:chExt cx="4534243" cy="1183303"/>
          </a:xfrm>
        </p:grpSpPr>
        <p:pic>
          <p:nvPicPr>
            <p:cNvPr id="32" name="Picture 31" descr="A graph showing a curve&#10;&#10;AI-generated content may be incorrect.">
              <a:extLst>
                <a:ext uri="{FF2B5EF4-FFF2-40B4-BE49-F238E27FC236}">
                  <a16:creationId xmlns:a16="http://schemas.microsoft.com/office/drawing/2014/main" id="{BEA4003E-0338-62A3-C049-8C12086F068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alphaModFix/>
            </a:blip>
            <a:stretch>
              <a:fillRect/>
            </a:stretch>
          </p:blipFill>
          <p:spPr>
            <a:xfrm>
              <a:off x="2659494" y="6381713"/>
              <a:ext cx="1470718" cy="896112"/>
            </a:xfrm>
            <a:prstGeom prst="rect">
              <a:avLst/>
            </a:prstGeom>
          </p:spPr>
        </p:pic>
        <p:pic>
          <p:nvPicPr>
            <p:cNvPr id="17" name="Picture 16" descr="A black and white graph&#10;&#10;AI-generated content may be incorrect.">
              <a:extLst>
                <a:ext uri="{FF2B5EF4-FFF2-40B4-BE49-F238E27FC236}">
                  <a16:creationId xmlns:a16="http://schemas.microsoft.com/office/drawing/2014/main" id="{460C9BDF-6CD8-5E50-1B85-E5685555FF5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alphaModFix/>
            </a:blip>
            <a:stretch>
              <a:fillRect/>
            </a:stretch>
          </p:blipFill>
          <p:spPr>
            <a:xfrm>
              <a:off x="1080287" y="6369979"/>
              <a:ext cx="1470718" cy="896112"/>
            </a:xfrm>
            <a:prstGeom prst="rect">
              <a:avLst/>
            </a:prstGeom>
          </p:spPr>
        </p:pic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3D8736A7-30AB-6C9D-F5AE-E52C2CB1EBD0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333115" y="6628159"/>
              <a:ext cx="822960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% of Total</a:t>
              </a:r>
            </a:p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FF91CC39-2BE3-F115-7CDD-3A4C3B550FE6}"/>
                </a:ext>
              </a:extLst>
            </p:cNvPr>
            <p:cNvSpPr txBox="1">
              <a:spLocks/>
            </p:cNvSpPr>
            <p:nvPr/>
          </p:nvSpPr>
          <p:spPr>
            <a:xfrm>
              <a:off x="3172755" y="6344005"/>
              <a:ext cx="336632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G6pc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6A5EBDB1-710E-F56E-3012-6F0992FD542A}"/>
                </a:ext>
              </a:extLst>
            </p:cNvPr>
            <p:cNvSpPr txBox="1">
              <a:spLocks/>
            </p:cNvSpPr>
            <p:nvPr/>
          </p:nvSpPr>
          <p:spPr>
            <a:xfrm>
              <a:off x="1566563" y="6344007"/>
              <a:ext cx="392736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1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epck</a:t>
              </a:r>
              <a:endParaRPr 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E48B469B-3536-9F77-5B20-2CE176942933}"/>
                </a:ext>
              </a:extLst>
            </p:cNvPr>
            <p:cNvSpPr txBox="1">
              <a:spLocks/>
            </p:cNvSpPr>
            <p:nvPr/>
          </p:nvSpPr>
          <p:spPr>
            <a:xfrm>
              <a:off x="1198788" y="7233240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ACDDE168-2A89-2325-A9DE-45FC0278A075}"/>
                </a:ext>
              </a:extLst>
            </p:cNvPr>
            <p:cNvSpPr txBox="1">
              <a:spLocks/>
            </p:cNvSpPr>
            <p:nvPr/>
          </p:nvSpPr>
          <p:spPr>
            <a:xfrm>
              <a:off x="2406306" y="7233240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C86166D-0652-1F85-5686-3BC4DCCD9570}"/>
                </a:ext>
              </a:extLst>
            </p:cNvPr>
            <p:cNvSpPr txBox="1">
              <a:spLocks/>
            </p:cNvSpPr>
            <p:nvPr/>
          </p:nvSpPr>
          <p:spPr>
            <a:xfrm>
              <a:off x="1709455" y="7233240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A8D067B4-7448-597C-63E6-B056074D9F30}"/>
                </a:ext>
              </a:extLst>
            </p:cNvPr>
            <p:cNvSpPr txBox="1">
              <a:spLocks/>
            </p:cNvSpPr>
            <p:nvPr/>
          </p:nvSpPr>
          <p:spPr>
            <a:xfrm>
              <a:off x="2774678" y="7233240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A35C2E58-E5D1-1504-43D3-0C80853C8993}"/>
                </a:ext>
              </a:extLst>
            </p:cNvPr>
            <p:cNvSpPr txBox="1">
              <a:spLocks/>
            </p:cNvSpPr>
            <p:nvPr/>
          </p:nvSpPr>
          <p:spPr>
            <a:xfrm>
              <a:off x="3984696" y="7233240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968842AB-C29B-DD88-8FFD-D90108835581}"/>
                </a:ext>
              </a:extLst>
            </p:cNvPr>
            <p:cNvSpPr txBox="1">
              <a:spLocks/>
            </p:cNvSpPr>
            <p:nvPr/>
          </p:nvSpPr>
          <p:spPr>
            <a:xfrm>
              <a:off x="3292557" y="7233240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2EFB77C7-6E90-529E-7F71-6009EB8FB9FD}"/>
                </a:ext>
              </a:extLst>
            </p:cNvPr>
            <p:cNvSpPr txBox="1">
              <a:spLocks/>
            </p:cNvSpPr>
            <p:nvPr/>
          </p:nvSpPr>
          <p:spPr>
            <a:xfrm>
              <a:off x="1648964" y="7344530"/>
              <a:ext cx="352661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ayer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A91299D3-A467-DEB5-DB47-95A89D5084B5}"/>
                </a:ext>
              </a:extLst>
            </p:cNvPr>
            <p:cNvSpPr txBox="1">
              <a:spLocks/>
            </p:cNvSpPr>
            <p:nvPr/>
          </p:nvSpPr>
          <p:spPr>
            <a:xfrm>
              <a:off x="3240392" y="7358031"/>
              <a:ext cx="352661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ayer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84060845-E7EB-4C60-C025-85D1C0682083}"/>
                </a:ext>
              </a:extLst>
            </p:cNvPr>
            <p:cNvSpPr txBox="1">
              <a:spLocks/>
            </p:cNvSpPr>
            <p:nvPr/>
          </p:nvSpPr>
          <p:spPr>
            <a:xfrm>
              <a:off x="1037120" y="7084514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CD6B3A14-9274-D93E-EA65-944D1210268D}"/>
                </a:ext>
              </a:extLst>
            </p:cNvPr>
            <p:cNvSpPr txBox="1">
              <a:spLocks/>
            </p:cNvSpPr>
            <p:nvPr/>
          </p:nvSpPr>
          <p:spPr>
            <a:xfrm>
              <a:off x="1036044" y="6730142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9E915161-FC39-B1C5-A557-995E520EF6AD}"/>
                </a:ext>
              </a:extLst>
            </p:cNvPr>
            <p:cNvSpPr txBox="1">
              <a:spLocks/>
            </p:cNvSpPr>
            <p:nvPr/>
          </p:nvSpPr>
          <p:spPr>
            <a:xfrm>
              <a:off x="963677" y="6372092"/>
              <a:ext cx="141064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233A6A77-7CD2-C815-AE31-84D8D4CACD43}"/>
                </a:ext>
              </a:extLst>
            </p:cNvPr>
            <p:cNvSpPr txBox="1">
              <a:spLocks/>
            </p:cNvSpPr>
            <p:nvPr/>
          </p:nvSpPr>
          <p:spPr>
            <a:xfrm>
              <a:off x="2610703" y="7086352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E26F2DF2-FC80-DD5E-15A1-EE8B5E1D3AE8}"/>
                </a:ext>
              </a:extLst>
            </p:cNvPr>
            <p:cNvSpPr txBox="1">
              <a:spLocks/>
            </p:cNvSpPr>
            <p:nvPr/>
          </p:nvSpPr>
          <p:spPr>
            <a:xfrm>
              <a:off x="2609627" y="6731980"/>
              <a:ext cx="70532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AE9607D5-88CC-78CE-182E-D2F3163DEE2C}"/>
                </a:ext>
              </a:extLst>
            </p:cNvPr>
            <p:cNvSpPr txBox="1">
              <a:spLocks/>
            </p:cNvSpPr>
            <p:nvPr/>
          </p:nvSpPr>
          <p:spPr>
            <a:xfrm>
              <a:off x="2537260" y="6373930"/>
              <a:ext cx="141064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CF1F529-EE48-08FB-E973-A70B781402DA}"/>
                </a:ext>
              </a:extLst>
            </p:cNvPr>
            <p:cNvSpPr txBox="1"/>
            <p:nvPr/>
          </p:nvSpPr>
          <p:spPr>
            <a:xfrm>
              <a:off x="4496893" y="6576253"/>
              <a:ext cx="5838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313F69C-F430-832F-44A0-48D70F671C91}"/>
                </a:ext>
              </a:extLst>
            </p:cNvPr>
            <p:cNvSpPr txBox="1"/>
            <p:nvPr/>
          </p:nvSpPr>
          <p:spPr>
            <a:xfrm>
              <a:off x="4487275" y="6792590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-KO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580BCAED-C39C-8680-6680-D2EB9173F2F1}"/>
                </a:ext>
              </a:extLst>
            </p:cNvPr>
            <p:cNvSpPr/>
            <p:nvPr/>
          </p:nvSpPr>
          <p:spPr>
            <a:xfrm>
              <a:off x="4371822" y="6638701"/>
              <a:ext cx="182880" cy="1828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37D3858A-D60C-03A1-6458-EE5F1B6A3D11}"/>
                </a:ext>
              </a:extLst>
            </p:cNvPr>
            <p:cNvSpPr/>
            <p:nvPr/>
          </p:nvSpPr>
          <p:spPr>
            <a:xfrm>
              <a:off x="4371822" y="6855038"/>
              <a:ext cx="182880" cy="182880"/>
            </a:xfrm>
            <a:prstGeom prst="rect">
              <a:avLst/>
            </a:prstGeom>
            <a:solidFill>
              <a:srgbClr val="8D8C8A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</p:grpSp>
    </p:spTree>
    <p:extLst>
      <p:ext uri="{BB962C8B-B14F-4D97-AF65-F5344CB8AC3E}">
        <p14:creationId xmlns:p14="http://schemas.microsoft.com/office/powerpoint/2010/main" val="38346942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1200" dirty="0" smtClean="0">
            <a:solidFill>
              <a:srgbClr val="FF0000"/>
            </a:solidFill>
            <a:highlight>
              <a:srgbClr val="FFFF00"/>
            </a:highlight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3209</TotalTime>
  <Words>121</Words>
  <Application>Microsoft Office PowerPoint</Application>
  <PresentationFormat>Letter Paper (8.5x11 in)</PresentationFormat>
  <Paragraphs>53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sulin regulates metabolism via zone-specific transcriptional programs</dc:title>
  <dc:creator>Biddinger Lab</dc:creator>
  <cp:lastModifiedBy>Schell, Mareike</cp:lastModifiedBy>
  <cp:revision>958</cp:revision>
  <cp:lastPrinted>2025-04-30T14:37:08Z</cp:lastPrinted>
  <dcterms:created xsi:type="dcterms:W3CDTF">2022-04-06T00:07:38Z</dcterms:created>
  <dcterms:modified xsi:type="dcterms:W3CDTF">2025-07-21T17:25:54Z</dcterms:modified>
</cp:coreProperties>
</file>